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3" r:id="rId8"/>
    <p:sldId id="264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291"/>
  </p:normalViewPr>
  <p:slideViewPr>
    <p:cSldViewPr snapToGrid="0" snapToObjects="1">
      <p:cViewPr varScale="1">
        <p:scale>
          <a:sx n="86" d="100"/>
          <a:sy n="86" d="100"/>
        </p:scale>
        <p:origin x="18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756941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583368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68924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7671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20451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313627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51762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108643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58384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764750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616200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48A71-7D02-FF49-8463-C628734CCA17}" type="datetimeFigureOut">
              <a:rPr lang="en-TH" smtClean="0"/>
              <a:t>13/7/2020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38114D-37E0-0B4C-9A2A-63AD4EC7DF0C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034501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81F3E8CD-398D-0F4B-9D9A-315FBFF3F9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8628" y="2286874"/>
            <a:ext cx="5060744" cy="334479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2A6CCA7-9B44-CA41-AAC7-5C88967912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0894" y="5946728"/>
            <a:ext cx="3918478" cy="365061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1731E57-5E0D-7946-95B1-37B7C585E8FB}"/>
              </a:ext>
            </a:extLst>
          </p:cNvPr>
          <p:cNvSpPr txBox="1"/>
          <p:nvPr/>
        </p:nvSpPr>
        <p:spPr>
          <a:xfrm>
            <a:off x="0" y="1917542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4A Full length blo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E96B745-9F45-6947-B3DE-09FCD0DB3FAD}"/>
              </a:ext>
            </a:extLst>
          </p:cNvPr>
          <p:cNvSpPr txBox="1"/>
          <p:nvPr/>
        </p:nvSpPr>
        <p:spPr>
          <a:xfrm>
            <a:off x="0" y="144186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</p:spTree>
    <p:extLst>
      <p:ext uri="{BB962C8B-B14F-4D97-AF65-F5344CB8AC3E}">
        <p14:creationId xmlns:p14="http://schemas.microsoft.com/office/powerpoint/2010/main" val="203569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E1731E57-5E0D-7946-95B1-37B7C585E8FB}"/>
              </a:ext>
            </a:extLst>
          </p:cNvPr>
          <p:cNvSpPr txBox="1"/>
          <p:nvPr/>
        </p:nvSpPr>
        <p:spPr>
          <a:xfrm>
            <a:off x="-119922" y="1315236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4C Full length blot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845E07F-0F5F-FA45-B4DE-122B273487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789" t="8952" r="9294"/>
          <a:stretch/>
        </p:blipFill>
        <p:spPr>
          <a:xfrm>
            <a:off x="1392211" y="1684568"/>
            <a:ext cx="4073577" cy="434490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373F64F-26D6-F546-AAAA-CCC13376970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5574"/>
          <a:stretch/>
        </p:blipFill>
        <p:spPr>
          <a:xfrm>
            <a:off x="1392211" y="5812627"/>
            <a:ext cx="4073577" cy="394918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4C5F7ED-CF0A-004A-83A5-F178CB98D411}"/>
              </a:ext>
            </a:extLst>
          </p:cNvPr>
          <p:cNvSpPr txBox="1"/>
          <p:nvPr/>
        </p:nvSpPr>
        <p:spPr>
          <a:xfrm>
            <a:off x="0" y="144186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</p:spTree>
    <p:extLst>
      <p:ext uri="{BB962C8B-B14F-4D97-AF65-F5344CB8AC3E}">
        <p14:creationId xmlns:p14="http://schemas.microsoft.com/office/powerpoint/2010/main" val="1342841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DBAC95-5719-5246-8B70-2997F2D74063}"/>
              </a:ext>
            </a:extLst>
          </p:cNvPr>
          <p:cNvSpPr txBox="1"/>
          <p:nvPr/>
        </p:nvSpPr>
        <p:spPr>
          <a:xfrm>
            <a:off x="9204" y="1626968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4C Full length blo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C2357A-3118-7044-B6BA-016CEC7AB4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7762" y="2171823"/>
            <a:ext cx="4344068" cy="414926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68DC914-2E2E-3B4C-9610-1406B4AB81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290" y="6321090"/>
            <a:ext cx="5219557" cy="339534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05A3F78-972A-4945-8AC9-4ED8E976260A}"/>
              </a:ext>
            </a:extLst>
          </p:cNvPr>
          <p:cNvSpPr txBox="1"/>
          <p:nvPr/>
        </p:nvSpPr>
        <p:spPr>
          <a:xfrm>
            <a:off x="0" y="189561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</p:spTree>
    <p:extLst>
      <p:ext uri="{BB962C8B-B14F-4D97-AF65-F5344CB8AC3E}">
        <p14:creationId xmlns:p14="http://schemas.microsoft.com/office/powerpoint/2010/main" val="3880176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7E9133-5CD0-6F47-ABDB-08000FE4CD51}"/>
              </a:ext>
            </a:extLst>
          </p:cNvPr>
          <p:cNvSpPr txBox="1"/>
          <p:nvPr/>
        </p:nvSpPr>
        <p:spPr>
          <a:xfrm>
            <a:off x="0" y="1491104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5A Full length blo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A2BB49-A921-AD45-BE18-C111CE7638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9376"/>
          <a:stretch/>
        </p:blipFill>
        <p:spPr>
          <a:xfrm>
            <a:off x="1359337" y="1959890"/>
            <a:ext cx="4561778" cy="406070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E04EF37-27B9-B74F-8A13-EF86ED29B15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7849"/>
          <a:stretch/>
        </p:blipFill>
        <p:spPr>
          <a:xfrm>
            <a:off x="978796" y="6310861"/>
            <a:ext cx="5139220" cy="339620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6C1E000-6A32-C544-8017-2548D7D03982}"/>
              </a:ext>
            </a:extLst>
          </p:cNvPr>
          <p:cNvSpPr txBox="1"/>
          <p:nvPr/>
        </p:nvSpPr>
        <p:spPr>
          <a:xfrm>
            <a:off x="18408" y="198931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</p:spTree>
    <p:extLst>
      <p:ext uri="{BB962C8B-B14F-4D97-AF65-F5344CB8AC3E}">
        <p14:creationId xmlns:p14="http://schemas.microsoft.com/office/powerpoint/2010/main" val="24974317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7E9133-5CD0-6F47-ABDB-08000FE4CD51}"/>
              </a:ext>
            </a:extLst>
          </p:cNvPr>
          <p:cNvSpPr txBox="1"/>
          <p:nvPr/>
        </p:nvSpPr>
        <p:spPr>
          <a:xfrm>
            <a:off x="0" y="1727768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5A Full length blot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E52DB77-0275-A941-8527-A370CCED90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3076" y="2321952"/>
            <a:ext cx="5258017" cy="371908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F34D943-5F00-FE4F-B652-E5559DDFB5C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858" b="20334"/>
          <a:stretch/>
        </p:blipFill>
        <p:spPr>
          <a:xfrm>
            <a:off x="823173" y="6265889"/>
            <a:ext cx="5757509" cy="34505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1C19F85-71E7-2D46-923D-A34F05B6D14A}"/>
              </a:ext>
            </a:extLst>
          </p:cNvPr>
          <p:cNvSpPr txBox="1"/>
          <p:nvPr/>
        </p:nvSpPr>
        <p:spPr>
          <a:xfrm>
            <a:off x="18408" y="189561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</p:spTree>
    <p:extLst>
      <p:ext uri="{BB962C8B-B14F-4D97-AF65-F5344CB8AC3E}">
        <p14:creationId xmlns:p14="http://schemas.microsoft.com/office/powerpoint/2010/main" val="14751321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7E9133-5CD0-6F47-ABDB-08000FE4CD51}"/>
              </a:ext>
            </a:extLst>
          </p:cNvPr>
          <p:cNvSpPr txBox="1"/>
          <p:nvPr/>
        </p:nvSpPr>
        <p:spPr>
          <a:xfrm>
            <a:off x="0" y="1727768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S1 Full length blo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C19F85-71E7-2D46-923D-A34F05B6D14A}"/>
              </a:ext>
            </a:extLst>
          </p:cNvPr>
          <p:cNvSpPr txBox="1"/>
          <p:nvPr/>
        </p:nvSpPr>
        <p:spPr>
          <a:xfrm>
            <a:off x="18408" y="189561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5FADAAC-E173-B44B-8544-AA40F62EFA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08" y="2333234"/>
            <a:ext cx="3598360" cy="385770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73FDD1C-37E4-7140-9209-99C0BAC735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7013" y="3102963"/>
            <a:ext cx="3185894" cy="305799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159A12C-CA9E-B544-A429-CC41ADFD3D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0196" y="6443272"/>
            <a:ext cx="2549520" cy="343274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EB30009-219A-314B-AC11-B7532C567D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87909" y="6538854"/>
            <a:ext cx="2653823" cy="3241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63010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7E9133-5CD0-6F47-ABDB-08000FE4CD51}"/>
              </a:ext>
            </a:extLst>
          </p:cNvPr>
          <p:cNvSpPr txBox="1"/>
          <p:nvPr/>
        </p:nvSpPr>
        <p:spPr>
          <a:xfrm>
            <a:off x="0" y="1727768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S1 Full length blo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C19F85-71E7-2D46-923D-A34F05B6D14A}"/>
              </a:ext>
            </a:extLst>
          </p:cNvPr>
          <p:cNvSpPr txBox="1"/>
          <p:nvPr/>
        </p:nvSpPr>
        <p:spPr>
          <a:xfrm>
            <a:off x="18408" y="189561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33A1444-030F-1341-9811-BBAC2A91CA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439" y="2221356"/>
            <a:ext cx="2684932" cy="343274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508B6A3-1EC2-DE48-B896-068D55387B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5036" y="2221355"/>
            <a:ext cx="2206767" cy="343274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36CC951-9B4D-1E44-84C0-6B2514EB42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6905" y="6160957"/>
            <a:ext cx="2832591" cy="3264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1640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7E9133-5CD0-6F47-ABDB-08000FE4CD51}"/>
              </a:ext>
            </a:extLst>
          </p:cNvPr>
          <p:cNvSpPr txBox="1"/>
          <p:nvPr/>
        </p:nvSpPr>
        <p:spPr>
          <a:xfrm>
            <a:off x="0" y="1727768"/>
            <a:ext cx="683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dirty="0"/>
              <a:t>Figure S1 Full length blo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C19F85-71E7-2D46-923D-A34F05B6D14A}"/>
              </a:ext>
            </a:extLst>
          </p:cNvPr>
          <p:cNvSpPr txBox="1"/>
          <p:nvPr/>
        </p:nvSpPr>
        <p:spPr>
          <a:xfrm>
            <a:off x="18408" y="189561"/>
            <a:ext cx="683959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ctin affinity chromatography and quantitative proteomic analysis reveal that galectin-3 is associated with metastasis in nasopharyngeal carcinoma</a:t>
            </a:r>
          </a:p>
          <a:p>
            <a:pPr algn="ctr"/>
            <a:endParaRPr lang="en-US" sz="1600" dirty="0"/>
          </a:p>
          <a:p>
            <a:pPr algn="ctr"/>
            <a:r>
              <a:rPr lang="en-US" sz="1600" dirty="0" err="1"/>
              <a:t>Sathid</a:t>
            </a:r>
            <a:r>
              <a:rPr lang="en-US" sz="1600" dirty="0"/>
              <a:t> </a:t>
            </a:r>
            <a:r>
              <a:rPr lang="en-US" sz="1600" dirty="0" err="1"/>
              <a:t>Aimjongjun</a:t>
            </a:r>
            <a:r>
              <a:rPr lang="en-US" sz="1600" dirty="0"/>
              <a:t>, </a:t>
            </a:r>
            <a:r>
              <a:rPr lang="en-US" sz="1600" dirty="0" err="1"/>
              <a:t>Onrapak</a:t>
            </a:r>
            <a:r>
              <a:rPr lang="en-US" sz="1600" dirty="0"/>
              <a:t> </a:t>
            </a:r>
            <a:r>
              <a:rPr lang="en-US" sz="1600" dirty="0" err="1"/>
              <a:t>Reamtong</a:t>
            </a:r>
            <a:r>
              <a:rPr lang="en-US" sz="1600" dirty="0"/>
              <a:t>, </a:t>
            </a:r>
            <a:r>
              <a:rPr lang="en-US" sz="1600" dirty="0" err="1"/>
              <a:t>Tavan</a:t>
            </a:r>
            <a:r>
              <a:rPr lang="en-US" sz="1600" dirty="0"/>
              <a:t> </a:t>
            </a:r>
            <a:r>
              <a:rPr lang="en-US" sz="1600" dirty="0" err="1"/>
              <a:t>Janvilisri</a:t>
            </a:r>
            <a:endParaRPr lang="en-TH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9AA62A5-4F4D-4142-9824-3FA3218C6C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99190"/>
            <a:ext cx="6858000" cy="3507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5765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240</Words>
  <Application>Microsoft Macintosh PowerPoint</Application>
  <PresentationFormat>A4 Paper (210x297 mm)</PresentationFormat>
  <Paragraphs>3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van Janvilisri</dc:creator>
  <cp:lastModifiedBy>Tavan Janvilisri</cp:lastModifiedBy>
  <cp:revision>6</cp:revision>
  <dcterms:created xsi:type="dcterms:W3CDTF">2020-04-22T12:54:32Z</dcterms:created>
  <dcterms:modified xsi:type="dcterms:W3CDTF">2020-07-13T10:35:18Z</dcterms:modified>
</cp:coreProperties>
</file>